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F7D22C-E197-48E4-ADFF-6B4F3452B2B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FC51D0-B9B1-40F0-B4FB-FEF5973890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CE231B-FFD8-4142-9A0F-EAF0669A2BF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C76DFD-21CA-421C-B6BB-6C529B4B917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9E9DC5-88A9-41A7-A523-F956211374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2FF9BD-AF53-4666-B702-BFD251A05D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4F3B26-0847-403E-9ADF-244DB7E11A4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1917A0-4AEB-4980-839A-3411455602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6A468F-7883-4690-9038-7C9C675918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FF4C7F-4992-4A47-82DB-45315A20C7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AE1F06-0B92-4226-B700-C1885A04BD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BAE149-9B74-4BC1-B63C-84B8494A55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4D17759-ABE2-40E3-9A26-76D31DAA5FF6}" type="slidenum">
              <a:rPr b="0" lang="en-US" sz="1200" spc="-1" strike="noStrike">
                <a:solidFill>
                  <a:srgbClr val="898989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Chart 7" descr=""/>
          <p:cNvPicPr/>
          <p:nvPr/>
        </p:nvPicPr>
        <p:blipFill>
          <a:blip r:embed="rId1"/>
          <a:stretch/>
        </p:blipFill>
        <p:spPr>
          <a:xfrm>
            <a:off x="1371600" y="914400"/>
            <a:ext cx="8686800" cy="4724280"/>
          </a:xfrm>
          <a:prstGeom prst="rect">
            <a:avLst/>
          </a:prstGeom>
          <a:ln w="0">
            <a:noFill/>
          </a:ln>
        </p:spPr>
      </p:pic>
      <p:sp>
        <p:nvSpPr>
          <p:cNvPr id="42" name="Rectangle 6"/>
          <p:cNvSpPr/>
          <p:nvPr/>
        </p:nvSpPr>
        <p:spPr>
          <a:xfrm>
            <a:off x="2519640" y="2035080"/>
            <a:ext cx="997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Calibri"/>
                <a:ea typeface="Arial"/>
              </a:rPr>
              <a:t>p=0.016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1"/>
          <p:cNvSpPr/>
          <p:nvPr/>
        </p:nvSpPr>
        <p:spPr>
          <a:xfrm>
            <a:off x="2209680" y="5646600"/>
            <a:ext cx="76964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4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pi1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levels are significantly reduced in OP9-K cells after treatment with RNAi against Spi1.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xpression levels were measuring using relative quantification RT-PCR with biological and technical replicates.  Expression levels are shown relative to OP9-K cells treated with negative control RNAi.  p-value represents the significance level of knock down as calculated with a t-test.  Error bars represent the 95% confidence interval.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67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1-21T22:26:13Z</dcterms:created>
  <dc:creator>jackie l.</dc:creator>
  <dc:description/>
  <dc:language>en-US</dc:language>
  <cp:lastModifiedBy>Kosta</cp:lastModifiedBy>
  <dcterms:modified xsi:type="dcterms:W3CDTF">2014-10-29T23:09:08Z</dcterms:modified>
  <cp:revision>10</cp:revision>
  <dc:subject/>
  <dc:title>Slide 1</dc:title>
</cp:coreProperties>
</file>